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63" r:id="rId4"/>
    <p:sldId id="261" r:id="rId5"/>
    <p:sldId id="260" r:id="rId6"/>
    <p:sldId id="257" r:id="rId7"/>
    <p:sldId id="258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7" d="100"/>
          <a:sy n="47" d="100"/>
        </p:scale>
        <p:origin x="5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197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0111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3418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43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3544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48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730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1128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755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714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508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FA4929-4A74-4373-8F06-08B968353689}" type="datetimeFigureOut">
              <a:rPr lang="zh-CN" altLang="en-US" smtClean="0"/>
              <a:t>2025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B94AD4-6159-4E4C-ACC8-D4C4BCC9FB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1855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tiff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tiff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image" Target="../media/image17.png"/><Relationship Id="rId16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tiff"/><Relationship Id="rId10" Type="http://schemas.openxmlformats.org/officeDocument/2006/relationships/image" Target="../media/image25.tiff"/><Relationship Id="rId4" Type="http://schemas.openxmlformats.org/officeDocument/2006/relationships/image" Target="../media/image19.png"/><Relationship Id="rId9" Type="http://schemas.openxmlformats.org/officeDocument/2006/relationships/image" Target="../media/image24.tiff"/><Relationship Id="rId14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13" Type="http://schemas.openxmlformats.org/officeDocument/2006/relationships/image" Target="../media/image44.tiff"/><Relationship Id="rId3" Type="http://schemas.openxmlformats.org/officeDocument/2006/relationships/image" Target="../media/image34.tiff"/><Relationship Id="rId7" Type="http://schemas.openxmlformats.org/officeDocument/2006/relationships/image" Target="../media/image38.tiff"/><Relationship Id="rId12" Type="http://schemas.openxmlformats.org/officeDocument/2006/relationships/image" Target="../media/image43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tiff"/><Relationship Id="rId11" Type="http://schemas.openxmlformats.org/officeDocument/2006/relationships/image" Target="../media/image42.tiff"/><Relationship Id="rId5" Type="http://schemas.openxmlformats.org/officeDocument/2006/relationships/image" Target="../media/image36.tiff"/><Relationship Id="rId15" Type="http://schemas.openxmlformats.org/officeDocument/2006/relationships/image" Target="../media/image46.png"/><Relationship Id="rId10" Type="http://schemas.openxmlformats.org/officeDocument/2006/relationships/image" Target="../media/image41.tiff"/><Relationship Id="rId4" Type="http://schemas.openxmlformats.org/officeDocument/2006/relationships/image" Target="../media/image35.tiff"/><Relationship Id="rId9" Type="http://schemas.openxmlformats.org/officeDocument/2006/relationships/image" Target="../media/image40.png"/><Relationship Id="rId14" Type="http://schemas.openxmlformats.org/officeDocument/2006/relationships/image" Target="../media/image4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tiff"/><Relationship Id="rId2" Type="http://schemas.openxmlformats.org/officeDocument/2006/relationships/image" Target="../media/image5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tiff"/><Relationship Id="rId5" Type="http://schemas.openxmlformats.org/officeDocument/2006/relationships/image" Target="../media/image54.tiff"/><Relationship Id="rId4" Type="http://schemas.openxmlformats.org/officeDocument/2006/relationships/image" Target="../media/image53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7.tiff"/><Relationship Id="rId7" Type="http://schemas.openxmlformats.org/officeDocument/2006/relationships/image" Target="../media/image61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5" Type="http://schemas.openxmlformats.org/officeDocument/2006/relationships/image" Target="../media/image59.tiff"/><Relationship Id="rId10" Type="http://schemas.openxmlformats.org/officeDocument/2006/relationships/image" Target="../media/image64.png"/><Relationship Id="rId4" Type="http://schemas.openxmlformats.org/officeDocument/2006/relationships/image" Target="../media/image58.tiff"/><Relationship Id="rId9" Type="http://schemas.openxmlformats.org/officeDocument/2006/relationships/image" Target="../media/image6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png"/><Relationship Id="rId5" Type="http://schemas.openxmlformats.org/officeDocument/2006/relationships/image" Target="../media/image68.png"/><Relationship Id="rId4" Type="http://schemas.openxmlformats.org/officeDocument/2006/relationships/image" Target="../media/image67.png"/><Relationship Id="rId9" Type="http://schemas.openxmlformats.org/officeDocument/2006/relationships/image" Target="../media/image7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片 6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843"/>
          <a:stretch/>
        </p:blipFill>
        <p:spPr>
          <a:xfrm>
            <a:off x="1353912" y="3338330"/>
            <a:ext cx="3972831" cy="857552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9144" y="1819685"/>
            <a:ext cx="4020692" cy="85421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4174" y="2708921"/>
            <a:ext cx="4066362" cy="918531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33558" y="24722"/>
            <a:ext cx="1175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1B</a:t>
            </a:r>
            <a:endParaRPr lang="zh-CN" altLang="en-US" b="1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5485" y="5963955"/>
            <a:ext cx="3165421" cy="54860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5486" y="5351066"/>
            <a:ext cx="3132156" cy="542843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73517" y="1075108"/>
            <a:ext cx="3517670" cy="708372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6783234" y="1248614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806474" y="5555355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6853175" y="6099646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853175" y="4781939"/>
            <a:ext cx="713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542466" y="3051298"/>
            <a:ext cx="1195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1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647304" y="2077514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672135" y="3899094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BM1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44604" y="4212839"/>
            <a:ext cx="3887855" cy="738377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56461" y="4582028"/>
            <a:ext cx="3741672" cy="698993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594174" y="3681162"/>
            <a:ext cx="4062583" cy="83318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44604" y="873445"/>
            <a:ext cx="3887855" cy="741903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65484" y="5019981"/>
            <a:ext cx="3769191" cy="752451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65484" y="5872771"/>
            <a:ext cx="3769191" cy="844353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8017404" y="1040543"/>
            <a:ext cx="2829896" cy="56650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 flipH="1">
            <a:off x="11079223" y="1212713"/>
            <a:ext cx="5058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1276141" y="468417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1557061" y="228588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1565196" y="3058116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1541351" y="4134327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0848626" y="553706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0838911" y="6061405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1522759" y="3872137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1522759" y="3702860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79289" y="1676142"/>
            <a:ext cx="4520843" cy="810881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1028" y="2523618"/>
            <a:ext cx="4579103" cy="800283"/>
          </a:xfrm>
          <a:prstGeom prst="rect">
            <a:avLst/>
          </a:prstGeom>
        </p:spPr>
      </p:pic>
      <p:sp>
        <p:nvSpPr>
          <p:cNvPr id="41" name="矩形 40"/>
          <p:cNvSpPr/>
          <p:nvPr/>
        </p:nvSpPr>
        <p:spPr>
          <a:xfrm>
            <a:off x="2014250" y="830968"/>
            <a:ext cx="2990037" cy="594467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文本框 13"/>
          <p:cNvSpPr txBox="1"/>
          <p:nvPr/>
        </p:nvSpPr>
        <p:spPr>
          <a:xfrm>
            <a:off x="721219" y="1063910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14"/>
          <p:cNvSpPr txBox="1"/>
          <p:nvPr/>
        </p:nvSpPr>
        <p:spPr>
          <a:xfrm>
            <a:off x="524207" y="522692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15"/>
          <p:cNvSpPr txBox="1"/>
          <p:nvPr/>
        </p:nvSpPr>
        <p:spPr>
          <a:xfrm>
            <a:off x="555295" y="605820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16"/>
          <p:cNvSpPr txBox="1"/>
          <p:nvPr/>
        </p:nvSpPr>
        <p:spPr>
          <a:xfrm>
            <a:off x="648793" y="4407011"/>
            <a:ext cx="713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17"/>
          <p:cNvSpPr txBox="1"/>
          <p:nvPr/>
        </p:nvSpPr>
        <p:spPr>
          <a:xfrm>
            <a:off x="357920" y="2768459"/>
            <a:ext cx="1195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1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18"/>
          <p:cNvSpPr txBox="1"/>
          <p:nvPr/>
        </p:nvSpPr>
        <p:spPr>
          <a:xfrm>
            <a:off x="475659" y="1873561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 flipH="1">
            <a:off x="5311835" y="1050705"/>
            <a:ext cx="5058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5297856" y="433634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5904254" y="196933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5867007" y="285710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5187564" y="520084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5140087" y="6022063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5290825" y="460596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5190694" y="494066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图片 6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362434" y="50765"/>
            <a:ext cx="3780506" cy="783658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017404" y="171225"/>
            <a:ext cx="3080329" cy="710845"/>
          </a:xfrm>
          <a:prstGeom prst="rect">
            <a:avLst/>
          </a:prstGeom>
        </p:spPr>
      </p:pic>
      <p:sp>
        <p:nvSpPr>
          <p:cNvPr id="67" name="文本框 66"/>
          <p:cNvSpPr txBox="1"/>
          <p:nvPr/>
        </p:nvSpPr>
        <p:spPr>
          <a:xfrm>
            <a:off x="524207" y="3548662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BM1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5226673" y="3652789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5224753" y="3476763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7482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32371" y="80447"/>
            <a:ext cx="1178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1C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1667" y="5302136"/>
            <a:ext cx="2762055" cy="693538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7555" y="4412972"/>
            <a:ext cx="2762054" cy="79439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74242" y="3778587"/>
            <a:ext cx="2762055" cy="60420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687948" y="111352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595503" y="544105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700604" y="4610185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927129" y="3918234"/>
            <a:ext cx="713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450542" y="2839898"/>
            <a:ext cx="1195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1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582185" y="1884564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5278" y="5866444"/>
            <a:ext cx="3654380" cy="68638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91971" y="4372274"/>
            <a:ext cx="3867200" cy="791256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43" b="18785"/>
          <a:stretch/>
        </p:blipFill>
        <p:spPr>
          <a:xfrm>
            <a:off x="7574243" y="1038819"/>
            <a:ext cx="2854272" cy="588868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6515621" y="3295589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BM1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91971" y="3511661"/>
            <a:ext cx="3755778" cy="774664"/>
          </a:xfrm>
          <a:prstGeom prst="rect">
            <a:avLst/>
          </a:prstGeom>
        </p:spPr>
      </p:pic>
      <p:sp>
        <p:nvSpPr>
          <p:cNvPr id="22" name="文本框 19"/>
          <p:cNvSpPr txBox="1"/>
          <p:nvPr/>
        </p:nvSpPr>
        <p:spPr>
          <a:xfrm>
            <a:off x="987038" y="3729716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BM1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5557672" y="3731033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544098" y="3543459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5"/>
          <a:stretch/>
        </p:blipFill>
        <p:spPr>
          <a:xfrm>
            <a:off x="2051846" y="848549"/>
            <a:ext cx="3634743" cy="667923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8"/>
          <a:stretch/>
        </p:blipFill>
        <p:spPr>
          <a:xfrm>
            <a:off x="1976451" y="5200656"/>
            <a:ext cx="3553834" cy="646015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61423" y="2723422"/>
            <a:ext cx="3511773" cy="716968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061423" y="1595150"/>
            <a:ext cx="3511773" cy="998083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614929" y="1658941"/>
            <a:ext cx="3180983" cy="844949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579722" y="2572647"/>
            <a:ext cx="3180983" cy="702845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" t="4734" r="-1006" b="5691"/>
          <a:stretch/>
        </p:blipFill>
        <p:spPr>
          <a:xfrm>
            <a:off x="7511667" y="3312680"/>
            <a:ext cx="3154719" cy="438600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 flipH="1">
            <a:off x="10186012" y="1196739"/>
            <a:ext cx="5058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0161903" y="391329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0666386" y="1899799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0604806" y="272342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0520927" y="3460944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0114926" y="552493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0114479" y="4610185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0532076" y="3298933"/>
            <a:ext cx="5883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273620" y="978370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870642" y="6117118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891805" y="5375208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262809" y="4612371"/>
            <a:ext cx="713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870642" y="2862975"/>
            <a:ext cx="1195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1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027055" y="1907573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5612774" y="457497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5296180" y="603501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5321486" y="5451549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flipH="1">
            <a:off x="5547747" y="978370"/>
            <a:ext cx="5058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5408950" y="1980556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5489908" y="2936938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5480849" y="315404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10615955" y="2957490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7818754" y="907144"/>
            <a:ext cx="2079830" cy="527594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矩形 55"/>
          <p:cNvSpPr/>
          <p:nvPr/>
        </p:nvSpPr>
        <p:spPr>
          <a:xfrm>
            <a:off x="2322303" y="776514"/>
            <a:ext cx="2464304" cy="577630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7" name="图片 56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814734" y="333388"/>
            <a:ext cx="2299746" cy="503754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821531" y="192578"/>
            <a:ext cx="3277925" cy="525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1889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5" t="14455" r="3231" b="19350"/>
          <a:stretch/>
        </p:blipFill>
        <p:spPr>
          <a:xfrm>
            <a:off x="2696147" y="3830809"/>
            <a:ext cx="2843916" cy="820266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45" t="56544" r="3266"/>
          <a:stretch/>
        </p:blipFill>
        <p:spPr>
          <a:xfrm>
            <a:off x="7832635" y="989107"/>
            <a:ext cx="2817320" cy="850659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855" b="21029"/>
          <a:stretch/>
        </p:blipFill>
        <p:spPr>
          <a:xfrm>
            <a:off x="7606325" y="5509278"/>
            <a:ext cx="2952029" cy="100148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6" t="9558" b="8356"/>
          <a:stretch/>
        </p:blipFill>
        <p:spPr>
          <a:xfrm>
            <a:off x="7577981" y="2815713"/>
            <a:ext cx="3062967" cy="82005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76" t="19023" b="-1"/>
          <a:stretch/>
        </p:blipFill>
        <p:spPr>
          <a:xfrm>
            <a:off x="7774029" y="3635770"/>
            <a:ext cx="3023720" cy="83952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714"/>
          <a:stretch/>
        </p:blipFill>
        <p:spPr>
          <a:xfrm>
            <a:off x="7606325" y="4515328"/>
            <a:ext cx="3012062" cy="93229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49" t="16340" b="3963"/>
          <a:stretch/>
        </p:blipFill>
        <p:spPr>
          <a:xfrm>
            <a:off x="7776584" y="1895830"/>
            <a:ext cx="2817320" cy="908964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7990114" y="933042"/>
            <a:ext cx="2373086" cy="568547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6981649" y="1238580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676599" y="4874524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768570" y="5840743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924252" y="3895178"/>
            <a:ext cx="713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507651" y="3075971"/>
            <a:ext cx="1195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1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768570" y="2201299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51799" y="275771"/>
            <a:ext cx="2311401" cy="590983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0493807" y="130703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482657" y="444482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585068" y="499784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472592" y="5768100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0457086" y="317147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612405" y="399476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0350440" y="228672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2" t="20235" r="4571" b="4935"/>
          <a:stretch/>
        </p:blipFill>
        <p:spPr>
          <a:xfrm>
            <a:off x="2705862" y="5506347"/>
            <a:ext cx="2855380" cy="1063439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4" t="16630" r="7866" b="25426"/>
          <a:stretch/>
        </p:blipFill>
        <p:spPr>
          <a:xfrm>
            <a:off x="2761194" y="4642936"/>
            <a:ext cx="2893210" cy="862061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7" t="17789" r="7406" b="16451"/>
          <a:stretch/>
        </p:blipFill>
        <p:spPr>
          <a:xfrm>
            <a:off x="2754353" y="2985585"/>
            <a:ext cx="2906891" cy="846193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6" t="61805" r="8755" b="1"/>
          <a:stretch/>
        </p:blipFill>
        <p:spPr>
          <a:xfrm>
            <a:off x="2705862" y="2002972"/>
            <a:ext cx="2911495" cy="919028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69"/>
          <a:stretch/>
        </p:blipFill>
        <p:spPr>
          <a:xfrm>
            <a:off x="2559350" y="991891"/>
            <a:ext cx="3070726" cy="933146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2940041" y="1029130"/>
            <a:ext cx="2373086" cy="568547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1773907" y="4904690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865878" y="587090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0533121" y="494709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0420645" y="5717350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391866" y="4003554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804249" y="125883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077612" y="4071116"/>
            <a:ext cx="713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661011" y="3251909"/>
            <a:ext cx="1195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1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743925" y="2321466"/>
            <a:ext cx="1064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TTL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498815" y="3145526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503665" y="244966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5498815" y="110034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39062" y="280668"/>
            <a:ext cx="3108364" cy="669265"/>
          </a:xfrm>
          <a:prstGeom prst="rect">
            <a:avLst/>
          </a:prstGeom>
        </p:spPr>
      </p:pic>
      <p:sp>
        <p:nvSpPr>
          <p:cNvPr id="46" name="文本框 45"/>
          <p:cNvSpPr txBox="1"/>
          <p:nvPr/>
        </p:nvSpPr>
        <p:spPr>
          <a:xfrm>
            <a:off x="98419" y="0"/>
            <a:ext cx="1200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1D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3914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1144" y="2698730"/>
            <a:ext cx="4908809" cy="205007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1143" y="4889140"/>
            <a:ext cx="4908809" cy="1077756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765353" y="2814392"/>
            <a:ext cx="3789176" cy="30099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1467217" y="3129543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360090" y="405411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385396" y="525874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016114" y="288477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004760" y="3298820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030066" y="3851504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030066" y="5156791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030066" y="4268325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4"/>
          <a:srcRect l="23719" t="3752"/>
          <a:stretch/>
        </p:blipFill>
        <p:spPr>
          <a:xfrm>
            <a:off x="2880940" y="1892852"/>
            <a:ext cx="2041005" cy="74804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5"/>
          <a:srcRect l="19832" t="1693"/>
          <a:stretch/>
        </p:blipFill>
        <p:spPr>
          <a:xfrm>
            <a:off x="4875705" y="1835021"/>
            <a:ext cx="2080080" cy="748047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3273423" y="573824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40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300953" y="573824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72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70991" y="131921"/>
            <a:ext cx="1191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2A</a:t>
            </a:r>
            <a:endParaRPr lang="zh-CN" altLang="en-US" b="1" dirty="0"/>
          </a:p>
        </p:txBody>
      </p:sp>
      <p:sp>
        <p:nvSpPr>
          <p:cNvPr id="19" name="文本框 18"/>
          <p:cNvSpPr txBox="1"/>
          <p:nvPr/>
        </p:nvSpPr>
        <p:spPr>
          <a:xfrm>
            <a:off x="3768814" y="1378326"/>
            <a:ext cx="707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40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476964" y="1378326"/>
            <a:ext cx="707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72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65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88" r="2502"/>
          <a:stretch/>
        </p:blipFill>
        <p:spPr>
          <a:xfrm>
            <a:off x="8387651" y="2426808"/>
            <a:ext cx="3323775" cy="91202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77" t="49048" r="5496" b="29489"/>
          <a:stretch/>
        </p:blipFill>
        <p:spPr>
          <a:xfrm>
            <a:off x="8387651" y="4543518"/>
            <a:ext cx="3098801" cy="108857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11" t="12847" r="5130" b="67121"/>
          <a:stretch/>
        </p:blipFill>
        <p:spPr>
          <a:xfrm>
            <a:off x="8387651" y="3433175"/>
            <a:ext cx="3127829" cy="1016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78"/>
          <a:stretch/>
        </p:blipFill>
        <p:spPr>
          <a:xfrm>
            <a:off x="1192692" y="2423232"/>
            <a:ext cx="5080797" cy="104067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41"/>
          <a:stretch/>
        </p:blipFill>
        <p:spPr>
          <a:xfrm>
            <a:off x="1228579" y="3520195"/>
            <a:ext cx="5066283" cy="104067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65" y="4617158"/>
            <a:ext cx="2969014" cy="960217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7457925" y="3771898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457925" y="4965723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459510" y="2578073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0878" y="395561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40878" y="4972137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42463" y="2761786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1314917" y="3760116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303007" y="4181400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1277653" y="4846895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486452" y="2667125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1468568" y="2426808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168237" y="3639620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168237" y="405764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085858" y="4883862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6225057" y="2921878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207173" y="2681561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197265" y="2484192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8671198" y="2469756"/>
            <a:ext cx="2463607" cy="30099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1644061" y="2484192"/>
            <a:ext cx="2463607" cy="30099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3009650" y="145635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40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9765190" y="145635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72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939845" y="202838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DD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986067" y="2039177"/>
            <a:ext cx="21970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      3         6       1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8937793" y="2015328"/>
            <a:ext cx="21970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      3         6       1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7587142" y="2076472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DD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81557" y="267023"/>
            <a:ext cx="1175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4B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832899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24237" y="3450861"/>
            <a:ext cx="4411206" cy="902194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37" t="39863"/>
          <a:stretch>
            <a:fillRect/>
          </a:stretch>
        </p:blipFill>
        <p:spPr>
          <a:xfrm>
            <a:off x="7114492" y="2697620"/>
            <a:ext cx="4430700" cy="739812"/>
          </a:xfrm>
          <a:custGeom>
            <a:avLst/>
            <a:gdLst>
              <a:gd name="connsiteX0" fmla="*/ 0 w 3998561"/>
              <a:gd name="connsiteY0" fmla="*/ 0 h 667656"/>
              <a:gd name="connsiteX1" fmla="*/ 3998561 w 3998561"/>
              <a:gd name="connsiteY1" fmla="*/ 0 h 667656"/>
              <a:gd name="connsiteX2" fmla="*/ 3998561 w 3998561"/>
              <a:gd name="connsiteY2" fmla="*/ 667656 h 667656"/>
              <a:gd name="connsiteX3" fmla="*/ 0 w 3998561"/>
              <a:gd name="connsiteY3" fmla="*/ 667656 h 6676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998561" h="667656">
                <a:moveTo>
                  <a:pt x="0" y="0"/>
                </a:moveTo>
                <a:lnTo>
                  <a:pt x="3998561" y="0"/>
                </a:lnTo>
                <a:lnTo>
                  <a:pt x="3998561" y="667656"/>
                </a:lnTo>
                <a:lnTo>
                  <a:pt x="0" y="667656"/>
                </a:lnTo>
                <a:close/>
              </a:path>
            </a:pathLst>
          </a:cu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37" t="19931" b="12567"/>
          <a:stretch>
            <a:fillRect/>
          </a:stretch>
        </p:blipFill>
        <p:spPr>
          <a:xfrm>
            <a:off x="7114491" y="4385172"/>
            <a:ext cx="4430698" cy="830412"/>
          </a:xfrm>
          <a:custGeom>
            <a:avLst/>
            <a:gdLst>
              <a:gd name="connsiteX0" fmla="*/ 0 w 3998562"/>
              <a:gd name="connsiteY0" fmla="*/ 0 h 749420"/>
              <a:gd name="connsiteX1" fmla="*/ 3998562 w 3998562"/>
              <a:gd name="connsiteY1" fmla="*/ 0 h 749420"/>
              <a:gd name="connsiteX2" fmla="*/ 3998562 w 3998562"/>
              <a:gd name="connsiteY2" fmla="*/ 749420 h 749420"/>
              <a:gd name="connsiteX3" fmla="*/ 0 w 3998562"/>
              <a:gd name="connsiteY3" fmla="*/ 749420 h 7494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998562" h="749420">
                <a:moveTo>
                  <a:pt x="0" y="0"/>
                </a:moveTo>
                <a:lnTo>
                  <a:pt x="3998562" y="0"/>
                </a:lnTo>
                <a:lnTo>
                  <a:pt x="3998562" y="749420"/>
                </a:lnTo>
                <a:lnTo>
                  <a:pt x="0" y="749420"/>
                </a:lnTo>
                <a:close/>
              </a:path>
            </a:pathLst>
          </a:cu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53" t="9578" b="9183"/>
          <a:stretch>
            <a:fillRect/>
          </a:stretch>
        </p:blipFill>
        <p:spPr>
          <a:xfrm>
            <a:off x="7081833" y="5299471"/>
            <a:ext cx="4503073" cy="999409"/>
          </a:xfrm>
          <a:custGeom>
            <a:avLst/>
            <a:gdLst>
              <a:gd name="connsiteX0" fmla="*/ 0 w 4063876"/>
              <a:gd name="connsiteY0" fmla="*/ 0 h 901934"/>
              <a:gd name="connsiteX1" fmla="*/ 4063876 w 4063876"/>
              <a:gd name="connsiteY1" fmla="*/ 0 h 901934"/>
              <a:gd name="connsiteX2" fmla="*/ 4063876 w 4063876"/>
              <a:gd name="connsiteY2" fmla="*/ 901934 h 901934"/>
              <a:gd name="connsiteX3" fmla="*/ 0 w 4063876"/>
              <a:gd name="connsiteY3" fmla="*/ 901934 h 9019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063876" h="901934">
                <a:moveTo>
                  <a:pt x="0" y="0"/>
                </a:moveTo>
                <a:lnTo>
                  <a:pt x="4063876" y="0"/>
                </a:lnTo>
                <a:lnTo>
                  <a:pt x="4063876" y="901934"/>
                </a:lnTo>
                <a:lnTo>
                  <a:pt x="0" y="901934"/>
                </a:lnTo>
                <a:close/>
              </a:path>
            </a:pathLst>
          </a:custGeom>
        </p:spPr>
      </p:pic>
      <p:sp>
        <p:nvSpPr>
          <p:cNvPr id="14" name="矩形 13"/>
          <p:cNvSpPr/>
          <p:nvPr/>
        </p:nvSpPr>
        <p:spPr>
          <a:xfrm>
            <a:off x="7412034" y="2616363"/>
            <a:ext cx="2772229" cy="375194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11581159" y="3399488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581158" y="3762336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1584906" y="444070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561028" y="4838338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1528601" y="5564035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1525283" y="3005129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1523108" y="2793917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12034" y="1568222"/>
            <a:ext cx="3031753" cy="964254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6080627" y="3786142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6080627" y="466906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152107" y="5757792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068063" y="2903223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8135258" y="687155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4E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161673" y="129137"/>
            <a:ext cx="1200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4D</a:t>
            </a:r>
            <a:endParaRPr lang="zh-CN" altLang="en-US" b="1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3058" y="4492334"/>
            <a:ext cx="4634105" cy="222801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6630" y="2419506"/>
            <a:ext cx="4634105" cy="89249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6630" y="3383061"/>
            <a:ext cx="4632343" cy="1038212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1233381" y="2386318"/>
            <a:ext cx="2594025" cy="421943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103573" y="3756954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0843" y="4826475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0" y="5878671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585" y="2704758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360253" y="351337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5336996" y="3842380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5280983" y="4538668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243693" y="490135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5252358" y="6129603"/>
            <a:ext cx="417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5275757" y="2718206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273582" y="2506994"/>
            <a:ext cx="578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72640" y="1105582"/>
            <a:ext cx="2428875" cy="1209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3295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823029" y="498469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4K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6678" y="4907454"/>
            <a:ext cx="4668002" cy="1635932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51423" y="4983553"/>
            <a:ext cx="4297125" cy="163426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6678" y="3850828"/>
            <a:ext cx="4668002" cy="100145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51423" y="3925260"/>
            <a:ext cx="4313853" cy="979937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6678" y="2765063"/>
            <a:ext cx="4668002" cy="103059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47810" y="2872364"/>
            <a:ext cx="4300738" cy="997729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561516" y="2709896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584680" y="3083501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556912" y="392692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570796" y="430053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580329" y="498355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556911" y="5826979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1569881" y="281719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593045" y="319080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1565277" y="3983429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579161" y="4328007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1588694" y="5119882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1565276" y="5927023"/>
            <a:ext cx="442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2076" y="3174006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6393" y="4154554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054" y="5980555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410564" y="2719324"/>
            <a:ext cx="3788228" cy="382406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7671162" y="2835361"/>
            <a:ext cx="3540675" cy="382406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6404534" y="3222957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A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6388851" y="4203505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6224910" y="5987589"/>
            <a:ext cx="929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箭头连接符 30"/>
          <p:cNvCxnSpPr/>
          <p:nvPr/>
        </p:nvCxnSpPr>
        <p:spPr>
          <a:xfrm>
            <a:off x="786582" y="6149832"/>
            <a:ext cx="522515" cy="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>
            <a:off x="7051860" y="6156866"/>
            <a:ext cx="522515" cy="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25" name="图片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99327" y="968707"/>
            <a:ext cx="3867150" cy="169545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9"/>
          <a:srcRect b="2587"/>
          <a:stretch/>
        </p:blipFill>
        <p:spPr>
          <a:xfrm>
            <a:off x="7671162" y="1383772"/>
            <a:ext cx="3781425" cy="1373233"/>
          </a:xfrm>
          <a:prstGeom prst="rect">
            <a:avLst/>
          </a:prstGeom>
        </p:spPr>
      </p:pic>
      <p:sp>
        <p:nvSpPr>
          <p:cNvPr id="39" name="文本框 38"/>
          <p:cNvSpPr txBox="1"/>
          <p:nvPr/>
        </p:nvSpPr>
        <p:spPr>
          <a:xfrm>
            <a:off x="8781143" y="498469"/>
            <a:ext cx="1148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4L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683422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6</TotalTime>
  <Words>202</Words>
  <Application>Microsoft Office PowerPoint</Application>
  <PresentationFormat>宽屏</PresentationFormat>
  <Paragraphs>174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n</dc:creator>
  <cp:lastModifiedBy>Nan</cp:lastModifiedBy>
  <cp:revision>93</cp:revision>
  <dcterms:created xsi:type="dcterms:W3CDTF">2024-11-25T06:45:25Z</dcterms:created>
  <dcterms:modified xsi:type="dcterms:W3CDTF">2025-01-24T02:05:34Z</dcterms:modified>
</cp:coreProperties>
</file>